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</p:sldIdLst>
  <p:sldSz cx="6858000" cy="9144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CC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185" autoAdjust="0"/>
    <p:restoredTop sz="94660"/>
  </p:normalViewPr>
  <p:slideViewPr>
    <p:cSldViewPr snapToGrid="0">
      <p:cViewPr>
        <p:scale>
          <a:sx n="200" d="100"/>
          <a:sy n="200" d="100"/>
        </p:scale>
        <p:origin x="834" y="33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679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8874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72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281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993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190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643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549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008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82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951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050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359348" y="8354003"/>
            <a:ext cx="4316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ditional file 1: Table S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4774895"/>
              </p:ext>
            </p:extLst>
          </p:nvPr>
        </p:nvGraphicFramePr>
        <p:xfrm>
          <a:off x="1599817" y="1646835"/>
          <a:ext cx="3743427" cy="5802297"/>
        </p:xfrm>
        <a:graphic>
          <a:graphicData uri="http://schemas.openxmlformats.org/drawingml/2006/table">
            <a:tbl>
              <a:tblPr/>
              <a:tblGrid>
                <a:gridCol w="119404">
                  <a:extLst>
                    <a:ext uri="{9D8B030D-6E8A-4147-A177-3AD203B41FA5}">
                      <a16:colId xmlns:a16="http://schemas.microsoft.com/office/drawing/2014/main" xmlns="" val="2250696126"/>
                    </a:ext>
                  </a:extLst>
                </a:gridCol>
                <a:gridCol w="904959">
                  <a:extLst>
                    <a:ext uri="{9D8B030D-6E8A-4147-A177-3AD203B41FA5}">
                      <a16:colId xmlns:a16="http://schemas.microsoft.com/office/drawing/2014/main" xmlns="" val="4131158267"/>
                    </a:ext>
                  </a:extLst>
                </a:gridCol>
                <a:gridCol w="691287">
                  <a:extLst>
                    <a:ext uri="{9D8B030D-6E8A-4147-A177-3AD203B41FA5}">
                      <a16:colId xmlns:a16="http://schemas.microsoft.com/office/drawing/2014/main" xmlns="" val="1970405506"/>
                    </a:ext>
                  </a:extLst>
                </a:gridCol>
                <a:gridCol w="2027777">
                  <a:extLst>
                    <a:ext uri="{9D8B030D-6E8A-4147-A177-3AD203B41FA5}">
                      <a16:colId xmlns:a16="http://schemas.microsoft.com/office/drawing/2014/main" xmlns="" val="3442892421"/>
                    </a:ext>
                  </a:extLst>
                </a:gridCol>
              </a:tblGrid>
              <a:tr h="12561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#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ble S1. Primers used for RT-qPCR analysis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632538951"/>
                  </a:ext>
                </a:extLst>
              </a:tr>
              <a:tr h="116825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80778879"/>
                  </a:ext>
                </a:extLst>
              </a:tr>
              <a:tr h="18214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imer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irection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equence (5'→ 3')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36166639"/>
                  </a:ext>
                </a:extLst>
              </a:tr>
              <a:tr h="116825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04265217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EM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CTTCCACCTGTGAGTCCCGA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39204106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TTCTCTGTTAGCAGCCACA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3992368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HLH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CAAATGCTTATATTGCCGAC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18892816"/>
                  </a:ext>
                </a:extLst>
              </a:tr>
              <a:tr h="119337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GCCTCTTCTCAATTTCACGAAC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1339937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CATCATTGAGACAAACCGCAC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0515154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AGTTCTTCACCAACGGGATGTC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93131096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OR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TCGCCAATTTGTGGACACG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20970975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TCTAGCAACAACCTCGAAAGAAG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78782480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OL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CAATGAAAGCGATGCTTAA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95704424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ACATTTCTTACTTCTTGCATCT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57497353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CAR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CTGCTTTGACTACACAAACGGAT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4536220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TTCAGCATTTCTCTTCCGCGTTC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98864004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GR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TCTTCATGTTCATTGTCACATTAG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778740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GTTCTTTGGTGAAAATGAAGA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46100931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GR-lik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GGTTTCTGATACTGCTGGACCT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41594769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CTCGGGATAATTCTTGTGTACTG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47882219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B113-like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CGAAGGCAAATGGCATCT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79604543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AAGCTTGTGAAGCCTTAGAATGAGAT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59779844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RF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CCACGACACATGGAAGCAC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80501706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GTATCTCGGCGACCCACTTG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00275183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L16-like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CTGACGATGCTTTTCTATGCCA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13288808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GAAACTGCGCCTGAACCAA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66170445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IF2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TGAGTGTCAAAGGAACCATG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31370239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CACCACCCTTCTATGGAAG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53815998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AC057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TTTCTACCTAGTCGAGATCCCGA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5731009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TTCCGATGTTGCGATTATGAC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1824989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NTL8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AATCCATCTCCGCACAAGGGAC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0294005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CCCGCCATTGCACTAACCAC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9306458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HN3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CCTTCTGCAATCTTAGCCGCCA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45407744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GATCCCCTCTTTCCTTTTACC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46102757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HB40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ACTGTCCTTGATAAATGCCGTC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90030349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GATATTCCATCCGATCGCTCC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99933889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B3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CAAGCTCCTCATGGACACCT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381606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GTTTTACCACCAACTGCCCT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00953276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YB4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GATATCATGCAAATTGAATCCG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90450174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TCAGAAGCCTTTGTTCATTTGCG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43140310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OFP6</a:t>
                      </a: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GATTATTATCAAGGCTTTTACTGAG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8152253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TGCCTTAAGTCATTTTGAACATGGA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29821212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ctin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AGGCAAAACCGGGCTCTATGAC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21418655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erse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TCCATTATCGCACACAAGTGGT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3456624"/>
                  </a:ext>
                </a:extLst>
              </a:tr>
              <a:tr h="11682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72479013"/>
                  </a:ext>
                </a:extLst>
              </a:tr>
              <a:tr h="125618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281" marR="6281" marT="62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694157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1556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6</TotalTime>
  <Words>124</Words>
  <Application>Microsoft Office PowerPoint</Application>
  <PresentationFormat>On-screen Show (4:3)</PresentationFormat>
  <Paragraphs>1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miya14</dc:creator>
  <cp:lastModifiedBy>Balindan, Danica Joy</cp:lastModifiedBy>
  <cp:revision>66</cp:revision>
  <cp:lastPrinted>2017-07-03T02:06:04Z</cp:lastPrinted>
  <dcterms:created xsi:type="dcterms:W3CDTF">2015-04-13T07:25:54Z</dcterms:created>
  <dcterms:modified xsi:type="dcterms:W3CDTF">2017-11-13T05:38:57Z</dcterms:modified>
</cp:coreProperties>
</file>